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2" r:id="rId2"/>
    <p:sldId id="273" r:id="rId3"/>
    <p:sldId id="274" r:id="rId4"/>
    <p:sldId id="275" r:id="rId5"/>
  </p:sldIdLst>
  <p:sldSz cx="12192000" cy="6858000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33" autoAdjust="0"/>
    <p:restoredTop sz="81882" autoAdjust="0"/>
  </p:normalViewPr>
  <p:slideViewPr>
    <p:cSldViewPr snapToGrid="0">
      <p:cViewPr varScale="1">
        <p:scale>
          <a:sx n="93" d="100"/>
          <a:sy n="93" d="100"/>
        </p:scale>
        <p:origin x="11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71054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66FB3FDC-144E-42C9-A8A4-81FFD281F559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32450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4"/>
            <a:ext cx="5681980" cy="3696712"/>
          </a:xfrm>
          <a:prstGeom prst="rect">
            <a:avLst/>
          </a:prstGeom>
        </p:spPr>
        <p:txBody>
          <a:bodyPr vert="horz" lIns="94229" tIns="47114" rIns="94229" bIns="4711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71053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D8B83A66-48E2-4208-9E97-37583B42EF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8294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0193">
              <a:defRPr/>
            </a:pPr>
            <a:r>
              <a:rPr lang="en-US" b="1" dirty="0"/>
              <a:t>Antibody and Dilution (CD63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CD63 (Abcam – ab213090) - 1:5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TSG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TSG (Abcam – ab125011) - 1:500</a:t>
            </a:r>
          </a:p>
          <a:p>
            <a:pPr defTabSz="960193">
              <a:defRPr/>
            </a:pPr>
            <a:r>
              <a:rPr lang="en-US" dirty="0"/>
              <a:t>        Secondary: Anti-Rabbit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Actin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Actin (Cell signaling – 8H10D10) - 1:20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B83A66-48E2-4208-9E97-37583B42EF0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0327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0193">
              <a:defRPr/>
            </a:pPr>
            <a:r>
              <a:rPr lang="en-US" b="1" dirty="0"/>
              <a:t>Antibody and Dilution (CD63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CD63 (Abcam – ab213090) - 1:5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TSG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TSG (Abcam – ab125011) - 1:500</a:t>
            </a:r>
          </a:p>
          <a:p>
            <a:pPr defTabSz="960193">
              <a:defRPr/>
            </a:pPr>
            <a:r>
              <a:rPr lang="en-US" dirty="0"/>
              <a:t>        Secondary: Anti-Rabbit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Actin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Actin (Cell signaling – 8H10D10) - 1:20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B83A66-48E2-4208-9E97-37583B42EF0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4554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0193">
              <a:defRPr/>
            </a:pPr>
            <a:r>
              <a:rPr lang="en-US" b="1" dirty="0"/>
              <a:t>Antibody and Dilution (CD63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CD63 (Abcam – ab213090) - 1:5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TSG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TSG (Abcam – ab125011) - 1:500</a:t>
            </a:r>
          </a:p>
          <a:p>
            <a:pPr defTabSz="960193">
              <a:defRPr/>
            </a:pPr>
            <a:r>
              <a:rPr lang="en-US" dirty="0"/>
              <a:t>        Secondary: Anti-Rabbit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Actin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Actin (Cell signaling – 8H10D10) - 1:20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B83A66-48E2-4208-9E97-37583B42EF0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64317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0193">
              <a:defRPr/>
            </a:pPr>
            <a:r>
              <a:rPr lang="en-US" b="1" dirty="0"/>
              <a:t>Antibody and Dilution (CD63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CD63 (Abcam – ab213090) - 1:5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TSG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TSG (Abcam – ab125011) - 1:500</a:t>
            </a:r>
          </a:p>
          <a:p>
            <a:pPr defTabSz="960193">
              <a:defRPr/>
            </a:pPr>
            <a:r>
              <a:rPr lang="en-US" dirty="0"/>
              <a:t>        Secondary: Anti-Rabbit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r>
              <a:rPr lang="en-US" b="1" dirty="0"/>
              <a:t>Antibody and Dilution (Actin)</a:t>
            </a:r>
          </a:p>
          <a:p>
            <a:pPr defTabSz="960193">
              <a:defRPr/>
            </a:pPr>
            <a:r>
              <a:rPr lang="en-US" b="1" dirty="0"/>
              <a:t>        </a:t>
            </a:r>
            <a:r>
              <a:rPr lang="en-US" dirty="0"/>
              <a:t>Blocking Solution: Odyssey                                                                                        </a:t>
            </a:r>
          </a:p>
          <a:p>
            <a:pPr defTabSz="960193">
              <a:defRPr/>
            </a:pPr>
            <a:r>
              <a:rPr lang="en-US" dirty="0"/>
              <a:t>        Primary: Actin (Cell signaling – 8H10D10) - 1:2000</a:t>
            </a:r>
          </a:p>
          <a:p>
            <a:pPr defTabSz="960193">
              <a:defRPr/>
            </a:pPr>
            <a:r>
              <a:rPr lang="en-US" dirty="0"/>
              <a:t>        Secondary: Anti-Mouse - 1:2000</a:t>
            </a:r>
          </a:p>
          <a:p>
            <a:pPr defTabSz="960193">
              <a:defRPr/>
            </a:pPr>
            <a:endParaRPr lang="en-US" dirty="0"/>
          </a:p>
          <a:p>
            <a:pPr defTabSz="960193"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B83A66-48E2-4208-9E97-37583B42EF0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578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8BC921-A239-D27D-9BFA-6816B98377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F3B603B-34DA-9F06-C8B2-AF37ED79CB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D41203-B7DF-0980-CA70-D551B33BD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2B031A-FACB-8793-CDA1-901ED5D99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B57567-18A7-E614-5C58-19BFCD2F6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622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FEDD52-E7C6-C38E-F3A1-534F205527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044DC6-A953-3286-0821-437CFA0593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6856B0-CBF4-3F25-B86D-BB6CFEC6D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F058F5-F80C-5F21-35F7-D153E1AF0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B5524C-0F73-5A75-4BCE-9A64B0501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397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B6DECC-21F8-B38B-278E-5492C142EB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2E725F-1024-72B4-F439-C052E560F4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58F361-70C5-1812-197D-610257422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CC48C9-356F-2859-846D-04321BAA0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030AB7-99F4-8009-0487-D9B602EA6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193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E13BF-CA2E-1796-F2B3-B1A939C22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7A65F2-7352-E142-9C72-CA8252C28D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034E82-CEC1-F98C-D259-557AFD974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2D89BE-0476-DFDE-F03F-A10A51124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1107C7-A658-D16B-471F-F7992DAD7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821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4E3F5-9D81-6937-BEB4-69665ABA0A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465EF9-BF5E-9831-5DEE-C2D7FD5FC7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A79E64-A22D-43B6-C287-7B8DBF9EB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CAB45A-11E1-C125-2F9C-849F4AEEE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26499B-463E-50BE-EE7D-CC8E7E8E2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152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9881B0-27E0-A992-1702-117CE278C8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03999B-7B2C-13C7-A566-1B7977FFA1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91ED4B-119D-301E-1526-47BABE3D2F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0F6BB9-A6E6-5EC2-E221-5B574B003B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08943D-BB12-DC72-8AD8-AE8C462E5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CC58A6-F775-7D12-4608-C506B0AF9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740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DF125B-FE04-BCF2-E2C4-1CADB2D7FB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A78C8D-1613-7D9B-0120-CD5721EAC1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878D6D-54A4-B4C1-A2E9-6958BDD689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84F4A4-4311-F3F1-EC58-609FE36851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A8F34A-E301-BA8B-734D-8D89C3CE8F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02D604-C4C2-9163-5705-72A2D6037C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D208B4-B6A6-16D9-08BC-FD3CAE279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7BEDDE-9FE9-A0A6-0754-DE06410883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6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BC0FFC-B692-465B-114A-9CBC2613E5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6E6DBD-05F5-0A84-C0B5-AA5CABA6F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93F935-668C-FE97-5DC8-CC72E98A1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B71641-DA57-C096-6326-5E5B49A1E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594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B5750A-89AE-40C2-EF26-08E2A642B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69C9A1E-1FDC-1AC0-7F9A-6DE64B304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041EC6-EC25-BDD4-7AC3-FD46657B7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404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39A3AD-4BBF-2293-70FB-B1FD066832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21636A-F295-C4C3-D227-D1A4B25965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8E1413-EBBA-5018-9B0B-7FB2854B23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C06E1B-D5FD-0CF7-2BC1-0AB8F0879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161053-542B-B562-FF27-6651D1DA2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EDB2E8-F118-4DE2-8BCA-7345D92C3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299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BC8F19-15C4-9534-BD54-50BB97410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3FD3ABA-546E-0A49-850A-B98D79F6E1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FCE33A-5C25-A4F9-12A4-93CE2B515E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A6910A-F3A6-7D98-28D1-65DD6C0CC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C14893-10D8-EDD8-525D-DB8108719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17EC8D-D94D-0080-804F-D5582DAA8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454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966580D-B0EF-DEAD-5793-08A99FF98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6D897E-BFF2-7A3D-60B3-5371FA969C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B804B1-71BC-2769-44BC-E19782A089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CB6312-6019-4CE6-A4E2-778CD0DDA04B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25B880-007B-BADE-1705-66879C903B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F29C1D-D95A-5D38-D85E-A01E933FC4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DCFD2-8136-424F-8B05-9D43DFB237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531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5.wdp"/><Relationship Id="rId5" Type="http://schemas.openxmlformats.org/officeDocument/2006/relationships/image" Target="../media/image6.png"/><Relationship Id="rId4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9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4.png"/><Relationship Id="rId4" Type="http://schemas.microsoft.com/office/2007/relationships/hdphoto" Target="../media/hdphoto6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microsoft.com/office/2007/relationships/hdphoto" Target="../media/hdphoto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>
            <a:extLst>
              <a:ext uri="{FF2B5EF4-FFF2-40B4-BE49-F238E27FC236}">
                <a16:creationId xmlns:a16="http://schemas.microsoft.com/office/drawing/2014/main" id="{72364E60-EF2A-1B45-E3B6-17F488E67254}"/>
              </a:ext>
            </a:extLst>
          </p:cNvPr>
          <p:cNvSpPr txBox="1"/>
          <p:nvPr/>
        </p:nvSpPr>
        <p:spPr>
          <a:xfrm>
            <a:off x="0" y="50808"/>
            <a:ext cx="10663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7/08/22</a:t>
            </a:r>
          </a:p>
          <a:p>
            <a:r>
              <a:rPr lang="en-US" dirty="0"/>
              <a:t>N=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70AED92-D38F-802E-A71D-2354D2EBF93D}"/>
              </a:ext>
            </a:extLst>
          </p:cNvPr>
          <p:cNvSpPr txBox="1"/>
          <p:nvPr/>
        </p:nvSpPr>
        <p:spPr>
          <a:xfrm>
            <a:off x="2081683" y="373725"/>
            <a:ext cx="1449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1 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88C4E57-D006-4DDA-3644-D2CAB16C01D1}"/>
              </a:ext>
            </a:extLst>
          </p:cNvPr>
          <p:cNvSpPr txBox="1"/>
          <p:nvPr/>
        </p:nvSpPr>
        <p:spPr>
          <a:xfrm>
            <a:off x="2065655" y="843247"/>
            <a:ext cx="19170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D63 (50kDa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A4B528F-80A8-5590-DA30-E87A2D3EAD1B}"/>
              </a:ext>
            </a:extLst>
          </p:cNvPr>
          <p:cNvSpPr txBox="1"/>
          <p:nvPr/>
        </p:nvSpPr>
        <p:spPr>
          <a:xfrm>
            <a:off x="7689186" y="332013"/>
            <a:ext cx="1449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2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AC969F8-509D-0FEA-FACD-2DC5118E265C}"/>
              </a:ext>
            </a:extLst>
          </p:cNvPr>
          <p:cNvSpPr txBox="1"/>
          <p:nvPr/>
        </p:nvSpPr>
        <p:spPr>
          <a:xfrm>
            <a:off x="7673158" y="801535"/>
            <a:ext cx="19170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TSG (50kDa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9A3288D-0A9F-FE05-82A8-F1391319D49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3798" y="2139994"/>
            <a:ext cx="3914775" cy="1066800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E51A0F9D-D1E9-811F-A27C-2D1017111432}"/>
              </a:ext>
            </a:extLst>
          </p:cNvPr>
          <p:cNvSpPr txBox="1"/>
          <p:nvPr/>
        </p:nvSpPr>
        <p:spPr>
          <a:xfrm>
            <a:off x="216423" y="2299599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7ECD74-EC92-69BD-62D5-DD90D75BBCFC}"/>
              </a:ext>
            </a:extLst>
          </p:cNvPr>
          <p:cNvSpPr txBox="1"/>
          <p:nvPr/>
        </p:nvSpPr>
        <p:spPr>
          <a:xfrm>
            <a:off x="190638" y="2615045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84BBE99-D42E-7821-B3FC-C2AC60CC5632}"/>
              </a:ext>
            </a:extLst>
          </p:cNvPr>
          <p:cNvSpPr txBox="1"/>
          <p:nvPr/>
        </p:nvSpPr>
        <p:spPr>
          <a:xfrm>
            <a:off x="216424" y="2119370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2573073-63BB-E825-BAEF-5BD39802650F}"/>
              </a:ext>
            </a:extLst>
          </p:cNvPr>
          <p:cNvSpPr txBox="1"/>
          <p:nvPr/>
        </p:nvSpPr>
        <p:spPr>
          <a:xfrm>
            <a:off x="190639" y="2917267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24F02A2-D02B-C09E-B7A0-FA8F7DBEB2F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t="-2633" b="-949"/>
          <a:stretch/>
        </p:blipFill>
        <p:spPr>
          <a:xfrm>
            <a:off x="6757687" y="2044670"/>
            <a:ext cx="3829050" cy="1183939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D56BDC3F-FA8D-DEEC-2809-3CB66CDC9500}"/>
              </a:ext>
            </a:extLst>
          </p:cNvPr>
          <p:cNvSpPr txBox="1"/>
          <p:nvPr/>
        </p:nvSpPr>
        <p:spPr>
          <a:xfrm>
            <a:off x="6267349" y="2250166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E90A5F5-C401-86C2-8A7B-0200CAF08A8F}"/>
              </a:ext>
            </a:extLst>
          </p:cNvPr>
          <p:cNvSpPr txBox="1"/>
          <p:nvPr/>
        </p:nvSpPr>
        <p:spPr>
          <a:xfrm>
            <a:off x="6267349" y="2575705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7DE441A-1C89-CB70-504F-7FB312E757B4}"/>
              </a:ext>
            </a:extLst>
          </p:cNvPr>
          <p:cNvSpPr txBox="1"/>
          <p:nvPr/>
        </p:nvSpPr>
        <p:spPr>
          <a:xfrm>
            <a:off x="6195214" y="2051204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1151C18-09C3-CF57-1CCF-A1F4D94AC3CA}"/>
              </a:ext>
            </a:extLst>
          </p:cNvPr>
          <p:cNvSpPr txBox="1"/>
          <p:nvPr/>
        </p:nvSpPr>
        <p:spPr>
          <a:xfrm>
            <a:off x="6267349" y="2849168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0E554AE-6647-6426-68FB-8E52E09048E6}"/>
              </a:ext>
            </a:extLst>
          </p:cNvPr>
          <p:cNvSpPr txBox="1"/>
          <p:nvPr/>
        </p:nvSpPr>
        <p:spPr>
          <a:xfrm>
            <a:off x="1682713" y="-76180"/>
            <a:ext cx="799720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Adipocytes derived from MSCs-Results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F4B2DCFA-5E1D-7F4B-CED7-B14F2BB3F75E}"/>
              </a:ext>
            </a:extLst>
          </p:cNvPr>
          <p:cNvCxnSpPr>
            <a:cxnSpLocks/>
          </p:cNvCxnSpPr>
          <p:nvPr/>
        </p:nvCxnSpPr>
        <p:spPr>
          <a:xfrm>
            <a:off x="1329446" y="2071054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6AEFEC54-94C9-F17E-75D0-D482DF5E119E}"/>
              </a:ext>
            </a:extLst>
          </p:cNvPr>
          <p:cNvCxnSpPr>
            <a:cxnSpLocks/>
          </p:cNvCxnSpPr>
          <p:nvPr/>
        </p:nvCxnSpPr>
        <p:spPr>
          <a:xfrm>
            <a:off x="1760626" y="2078491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DB422FF3-CC69-1972-D58A-4230078E511F}"/>
              </a:ext>
            </a:extLst>
          </p:cNvPr>
          <p:cNvCxnSpPr>
            <a:cxnSpLocks/>
          </p:cNvCxnSpPr>
          <p:nvPr/>
        </p:nvCxnSpPr>
        <p:spPr>
          <a:xfrm>
            <a:off x="2225257" y="2074777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49E8F45B-9539-9571-A1F2-5B955CC44BFC}"/>
              </a:ext>
            </a:extLst>
          </p:cNvPr>
          <p:cNvCxnSpPr>
            <a:cxnSpLocks/>
          </p:cNvCxnSpPr>
          <p:nvPr/>
        </p:nvCxnSpPr>
        <p:spPr>
          <a:xfrm>
            <a:off x="2645283" y="2082214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CCB902C3-9FE4-FCE2-EAF9-2D21C45BA1E8}"/>
              </a:ext>
            </a:extLst>
          </p:cNvPr>
          <p:cNvCxnSpPr>
            <a:cxnSpLocks/>
          </p:cNvCxnSpPr>
          <p:nvPr/>
        </p:nvCxnSpPr>
        <p:spPr>
          <a:xfrm>
            <a:off x="3098767" y="2078500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D348F340-9059-AC45-2405-7E2B3A21E113}"/>
              </a:ext>
            </a:extLst>
          </p:cNvPr>
          <p:cNvCxnSpPr>
            <a:cxnSpLocks/>
          </p:cNvCxnSpPr>
          <p:nvPr/>
        </p:nvCxnSpPr>
        <p:spPr>
          <a:xfrm>
            <a:off x="3661124" y="2077131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40C75C79-B675-17FD-F15F-B9E86310BE47}"/>
              </a:ext>
            </a:extLst>
          </p:cNvPr>
          <p:cNvSpPr txBox="1"/>
          <p:nvPr/>
        </p:nvSpPr>
        <p:spPr>
          <a:xfrm>
            <a:off x="1676748" y="1703660"/>
            <a:ext cx="5453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8D397F0-2431-694C-B475-2008FB790543}"/>
              </a:ext>
            </a:extLst>
          </p:cNvPr>
          <p:cNvSpPr txBox="1"/>
          <p:nvPr/>
        </p:nvSpPr>
        <p:spPr>
          <a:xfrm>
            <a:off x="1332118" y="1820708"/>
            <a:ext cx="56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107F3BCF-09DB-E436-1E3B-A2047D7B38DE}"/>
              </a:ext>
            </a:extLst>
          </p:cNvPr>
          <p:cNvCxnSpPr>
            <a:cxnSpLocks/>
          </p:cNvCxnSpPr>
          <p:nvPr/>
        </p:nvCxnSpPr>
        <p:spPr>
          <a:xfrm>
            <a:off x="2255924" y="1710675"/>
            <a:ext cx="17267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6BCA949B-8E13-AAEE-E537-F76C41873C8D}"/>
              </a:ext>
            </a:extLst>
          </p:cNvPr>
          <p:cNvSpPr txBox="1"/>
          <p:nvPr/>
        </p:nvSpPr>
        <p:spPr>
          <a:xfrm>
            <a:off x="2179455" y="1853707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9B3826F-B4C0-1E76-F3F1-2EBB357CA53B}"/>
              </a:ext>
            </a:extLst>
          </p:cNvPr>
          <p:cNvSpPr txBox="1"/>
          <p:nvPr/>
        </p:nvSpPr>
        <p:spPr>
          <a:xfrm>
            <a:off x="2600170" y="1851765"/>
            <a:ext cx="76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NK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80FA0E3-2713-75EB-A3B1-242A5EBB024D}"/>
              </a:ext>
            </a:extLst>
          </p:cNvPr>
          <p:cNvSpPr txBox="1"/>
          <p:nvPr/>
        </p:nvSpPr>
        <p:spPr>
          <a:xfrm>
            <a:off x="2963310" y="1820708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3E8AC02-9151-33A8-6ACC-A25C54328CF1}"/>
              </a:ext>
            </a:extLst>
          </p:cNvPr>
          <p:cNvSpPr txBox="1"/>
          <p:nvPr/>
        </p:nvSpPr>
        <p:spPr>
          <a:xfrm>
            <a:off x="3526664" y="1703660"/>
            <a:ext cx="6595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+pNK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D6C5260-131A-6D3F-16B9-5C4F67160C23}"/>
              </a:ext>
            </a:extLst>
          </p:cNvPr>
          <p:cNvSpPr txBox="1"/>
          <p:nvPr/>
        </p:nvSpPr>
        <p:spPr>
          <a:xfrm>
            <a:off x="2566720" y="1407131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osomes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3B2746E4-B250-ED8A-C1A0-02CAE1E11821}"/>
              </a:ext>
            </a:extLst>
          </p:cNvPr>
          <p:cNvCxnSpPr>
            <a:cxnSpLocks/>
          </p:cNvCxnSpPr>
          <p:nvPr/>
        </p:nvCxnSpPr>
        <p:spPr>
          <a:xfrm>
            <a:off x="7264394" y="2000512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828F3E86-6F95-01C1-B4C4-C5CB7014BEE0}"/>
              </a:ext>
            </a:extLst>
          </p:cNvPr>
          <p:cNvCxnSpPr>
            <a:cxnSpLocks/>
          </p:cNvCxnSpPr>
          <p:nvPr/>
        </p:nvCxnSpPr>
        <p:spPr>
          <a:xfrm>
            <a:off x="7695574" y="2007949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8A15E2B6-7757-13D2-40B0-B24BC062FE2C}"/>
              </a:ext>
            </a:extLst>
          </p:cNvPr>
          <p:cNvCxnSpPr>
            <a:cxnSpLocks/>
          </p:cNvCxnSpPr>
          <p:nvPr/>
        </p:nvCxnSpPr>
        <p:spPr>
          <a:xfrm>
            <a:off x="8160205" y="2004235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B6F2F5C8-9266-0DF6-264E-AB7FBF5D2F31}"/>
              </a:ext>
            </a:extLst>
          </p:cNvPr>
          <p:cNvCxnSpPr>
            <a:cxnSpLocks/>
          </p:cNvCxnSpPr>
          <p:nvPr/>
        </p:nvCxnSpPr>
        <p:spPr>
          <a:xfrm>
            <a:off x="8580231" y="2011672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A5ECBEB9-3298-42CE-1D13-21EA902809AA}"/>
              </a:ext>
            </a:extLst>
          </p:cNvPr>
          <p:cNvCxnSpPr>
            <a:cxnSpLocks/>
          </p:cNvCxnSpPr>
          <p:nvPr/>
        </p:nvCxnSpPr>
        <p:spPr>
          <a:xfrm>
            <a:off x="9033715" y="2007958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AA9FD3E7-CCD6-241E-86A7-3DA930514BA3}"/>
              </a:ext>
            </a:extLst>
          </p:cNvPr>
          <p:cNvCxnSpPr>
            <a:cxnSpLocks/>
          </p:cNvCxnSpPr>
          <p:nvPr/>
        </p:nvCxnSpPr>
        <p:spPr>
          <a:xfrm>
            <a:off x="9596072" y="2006589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9ADB3D8A-460A-CDC8-F0C1-F929EEA37030}"/>
              </a:ext>
            </a:extLst>
          </p:cNvPr>
          <p:cNvSpPr txBox="1"/>
          <p:nvPr/>
        </p:nvSpPr>
        <p:spPr>
          <a:xfrm>
            <a:off x="7611696" y="1633118"/>
            <a:ext cx="5453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F1C3B14-F603-B928-6687-B44CA0043829}"/>
              </a:ext>
            </a:extLst>
          </p:cNvPr>
          <p:cNvSpPr txBox="1"/>
          <p:nvPr/>
        </p:nvSpPr>
        <p:spPr>
          <a:xfrm>
            <a:off x="7267066" y="1750166"/>
            <a:ext cx="56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8BFE45FC-F4D9-63CB-394E-DE5C82EE59B3}"/>
              </a:ext>
            </a:extLst>
          </p:cNvPr>
          <p:cNvCxnSpPr>
            <a:cxnSpLocks/>
          </p:cNvCxnSpPr>
          <p:nvPr/>
        </p:nvCxnSpPr>
        <p:spPr>
          <a:xfrm>
            <a:off x="8190872" y="1640133"/>
            <a:ext cx="17267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5D875F47-5FF6-72FF-16A6-392B83407CCA}"/>
              </a:ext>
            </a:extLst>
          </p:cNvPr>
          <p:cNvSpPr txBox="1"/>
          <p:nvPr/>
        </p:nvSpPr>
        <p:spPr>
          <a:xfrm>
            <a:off x="8114403" y="1783165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BFF9DE7-50FE-6C06-85D8-C70A487CD112}"/>
              </a:ext>
            </a:extLst>
          </p:cNvPr>
          <p:cNvSpPr txBox="1"/>
          <p:nvPr/>
        </p:nvSpPr>
        <p:spPr>
          <a:xfrm>
            <a:off x="8535118" y="1781223"/>
            <a:ext cx="76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NK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4D2C887-EA02-5DAB-F539-1A1F1146C4BB}"/>
              </a:ext>
            </a:extLst>
          </p:cNvPr>
          <p:cNvSpPr txBox="1"/>
          <p:nvPr/>
        </p:nvSpPr>
        <p:spPr>
          <a:xfrm>
            <a:off x="8898258" y="1750166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D72A082-3D68-4E8D-A959-39821879E9B2}"/>
              </a:ext>
            </a:extLst>
          </p:cNvPr>
          <p:cNvSpPr txBox="1"/>
          <p:nvPr/>
        </p:nvSpPr>
        <p:spPr>
          <a:xfrm>
            <a:off x="9461612" y="1633118"/>
            <a:ext cx="6595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+pNK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518DC51-6E87-4284-596D-E40DF446B5C7}"/>
              </a:ext>
            </a:extLst>
          </p:cNvPr>
          <p:cNvSpPr txBox="1"/>
          <p:nvPr/>
        </p:nvSpPr>
        <p:spPr>
          <a:xfrm>
            <a:off x="8501668" y="1336589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osomes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456205A-96A4-C0E2-9718-198423C854F2}"/>
              </a:ext>
            </a:extLst>
          </p:cNvPr>
          <p:cNvSpPr txBox="1"/>
          <p:nvPr/>
        </p:nvSpPr>
        <p:spPr>
          <a:xfrm>
            <a:off x="1807214" y="4443639"/>
            <a:ext cx="19351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Actin 2 (42 </a:t>
            </a:r>
            <a:r>
              <a:rPr lang="en-US" sz="2000" b="1" dirty="0" err="1">
                <a:solidFill>
                  <a:srgbClr val="FF0000"/>
                </a:solidFill>
              </a:rPr>
              <a:t>kDa</a:t>
            </a:r>
            <a:r>
              <a:rPr lang="en-US" sz="2000" b="1" dirty="0">
                <a:solidFill>
                  <a:srgbClr val="FF0000"/>
                </a:solidFill>
              </a:rPr>
              <a:t>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C9E2700-AAEF-0BEC-F33A-604A20AA2668}"/>
              </a:ext>
            </a:extLst>
          </p:cNvPr>
          <p:cNvSpPr txBox="1"/>
          <p:nvPr/>
        </p:nvSpPr>
        <p:spPr>
          <a:xfrm>
            <a:off x="169108" y="4872312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429BA39-2682-5E1E-F65F-9F63673EEC7C}"/>
              </a:ext>
            </a:extLst>
          </p:cNvPr>
          <p:cNvSpPr txBox="1"/>
          <p:nvPr/>
        </p:nvSpPr>
        <p:spPr>
          <a:xfrm>
            <a:off x="172967" y="5191485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pic>
        <p:nvPicPr>
          <p:cNvPr id="101" name="Picture 100">
            <a:extLst>
              <a:ext uri="{FF2B5EF4-FFF2-40B4-BE49-F238E27FC236}">
                <a16:creationId xmlns:a16="http://schemas.microsoft.com/office/drawing/2014/main" id="{632F6082-573F-8F86-A556-FA3574100F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79261" y="4835432"/>
            <a:ext cx="3838575" cy="695325"/>
          </a:xfrm>
          <a:prstGeom prst="rect">
            <a:avLst/>
          </a:prstGeom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A408CA2-ADAE-E674-92AA-27331468ADA1}"/>
              </a:ext>
            </a:extLst>
          </p:cNvPr>
          <p:cNvCxnSpPr>
            <a:cxnSpLocks/>
          </p:cNvCxnSpPr>
          <p:nvPr/>
        </p:nvCxnSpPr>
        <p:spPr>
          <a:xfrm flipH="1">
            <a:off x="4617836" y="2797866"/>
            <a:ext cx="406227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>
            <a:extLst>
              <a:ext uri="{FF2B5EF4-FFF2-40B4-BE49-F238E27FC236}">
                <a16:creationId xmlns:a16="http://schemas.microsoft.com/office/drawing/2014/main" id="{7D1E73CA-F9AE-14A2-78A4-1B08A2BB76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324586" y="2818185"/>
            <a:ext cx="524301" cy="2316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4063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>
            <a:extLst>
              <a:ext uri="{FF2B5EF4-FFF2-40B4-BE49-F238E27FC236}">
                <a16:creationId xmlns:a16="http://schemas.microsoft.com/office/drawing/2014/main" id="{72364E60-EF2A-1B45-E3B6-17F488E67254}"/>
              </a:ext>
            </a:extLst>
          </p:cNvPr>
          <p:cNvSpPr txBox="1"/>
          <p:nvPr/>
        </p:nvSpPr>
        <p:spPr>
          <a:xfrm>
            <a:off x="0" y="50808"/>
            <a:ext cx="10663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7/21/22</a:t>
            </a:r>
          </a:p>
          <a:p>
            <a:r>
              <a:rPr lang="en-US" dirty="0"/>
              <a:t>N=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9B83820-BEB1-72AA-F2D6-9D3084AD9117}"/>
              </a:ext>
            </a:extLst>
          </p:cNvPr>
          <p:cNvSpPr txBox="1"/>
          <p:nvPr/>
        </p:nvSpPr>
        <p:spPr>
          <a:xfrm>
            <a:off x="1686363" y="3429220"/>
            <a:ext cx="19351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ctin 1 (42 </a:t>
            </a:r>
            <a:r>
              <a:rPr lang="en-US" sz="2000" b="1" dirty="0" err="1"/>
              <a:t>kDa</a:t>
            </a:r>
            <a:r>
              <a:rPr lang="en-US" sz="2000" b="1" dirty="0"/>
              <a:t>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62FDFF3-C70D-FD63-8D17-A9A811F09D82}"/>
              </a:ext>
            </a:extLst>
          </p:cNvPr>
          <p:cNvSpPr txBox="1"/>
          <p:nvPr/>
        </p:nvSpPr>
        <p:spPr>
          <a:xfrm>
            <a:off x="48257" y="3857893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EB30F5D-4B85-A8FF-3F0A-491A07EFEB49}"/>
              </a:ext>
            </a:extLst>
          </p:cNvPr>
          <p:cNvSpPr txBox="1"/>
          <p:nvPr/>
        </p:nvSpPr>
        <p:spPr>
          <a:xfrm>
            <a:off x="52116" y="4177066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70AED92-D38F-802E-A71D-2354D2EBF93D}"/>
              </a:ext>
            </a:extLst>
          </p:cNvPr>
          <p:cNvSpPr txBox="1"/>
          <p:nvPr/>
        </p:nvSpPr>
        <p:spPr>
          <a:xfrm>
            <a:off x="2027362" y="650758"/>
            <a:ext cx="1502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3  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88C4E57-D006-4DDA-3644-D2CAB16C01D1}"/>
              </a:ext>
            </a:extLst>
          </p:cNvPr>
          <p:cNvSpPr txBox="1"/>
          <p:nvPr/>
        </p:nvSpPr>
        <p:spPr>
          <a:xfrm>
            <a:off x="2011334" y="1120280"/>
            <a:ext cx="19170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D63 (50kDa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51A0F9D-D1E9-811F-A27C-2D1017111432}"/>
              </a:ext>
            </a:extLst>
          </p:cNvPr>
          <p:cNvSpPr txBox="1"/>
          <p:nvPr/>
        </p:nvSpPr>
        <p:spPr>
          <a:xfrm>
            <a:off x="151036" y="2480558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7ECD74-EC92-69BD-62D5-DD90D75BBCFC}"/>
              </a:ext>
            </a:extLst>
          </p:cNvPr>
          <p:cNvSpPr txBox="1"/>
          <p:nvPr/>
        </p:nvSpPr>
        <p:spPr>
          <a:xfrm>
            <a:off x="125251" y="2796004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84BBE99-D42E-7821-B3FC-C2AC60CC5632}"/>
              </a:ext>
            </a:extLst>
          </p:cNvPr>
          <p:cNvSpPr txBox="1"/>
          <p:nvPr/>
        </p:nvSpPr>
        <p:spPr>
          <a:xfrm>
            <a:off x="151037" y="2300329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2573073-63BB-E825-BAEF-5BD39802650F}"/>
              </a:ext>
            </a:extLst>
          </p:cNvPr>
          <p:cNvSpPr txBox="1"/>
          <p:nvPr/>
        </p:nvSpPr>
        <p:spPr>
          <a:xfrm>
            <a:off x="125252" y="3098226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8A3328D-3F3C-15C3-E531-034EAA0747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39659" y="2355857"/>
            <a:ext cx="3781425" cy="10287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C8B8B4D-91C2-7A0F-7E3C-86124AF5E88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13874" y="3872769"/>
            <a:ext cx="3807210" cy="532407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3EDC557D-2EBA-CB5F-4C6B-B06B1422E761}"/>
              </a:ext>
            </a:extLst>
          </p:cNvPr>
          <p:cNvSpPr txBox="1"/>
          <p:nvPr/>
        </p:nvSpPr>
        <p:spPr>
          <a:xfrm>
            <a:off x="1682713" y="-76180"/>
            <a:ext cx="799720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Adipocytes derived from MSCs-Results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C0D97F05-191D-EDC6-CE1A-56F0DB9A8902}"/>
              </a:ext>
            </a:extLst>
          </p:cNvPr>
          <p:cNvCxnSpPr>
            <a:cxnSpLocks/>
          </p:cNvCxnSpPr>
          <p:nvPr/>
        </p:nvCxnSpPr>
        <p:spPr>
          <a:xfrm>
            <a:off x="1242579" y="2248407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E5F2362D-8FFB-6627-EAC8-BE16E5E4D831}"/>
              </a:ext>
            </a:extLst>
          </p:cNvPr>
          <p:cNvCxnSpPr>
            <a:cxnSpLocks/>
          </p:cNvCxnSpPr>
          <p:nvPr/>
        </p:nvCxnSpPr>
        <p:spPr>
          <a:xfrm>
            <a:off x="1673759" y="2255844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C23887F2-EE24-3FD3-E83C-9CDB9DA2A023}"/>
              </a:ext>
            </a:extLst>
          </p:cNvPr>
          <p:cNvCxnSpPr>
            <a:cxnSpLocks/>
          </p:cNvCxnSpPr>
          <p:nvPr/>
        </p:nvCxnSpPr>
        <p:spPr>
          <a:xfrm>
            <a:off x="2138390" y="2252130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A9EE69F3-2F47-84AC-6225-64C931ED3A35}"/>
              </a:ext>
            </a:extLst>
          </p:cNvPr>
          <p:cNvCxnSpPr>
            <a:cxnSpLocks/>
          </p:cNvCxnSpPr>
          <p:nvPr/>
        </p:nvCxnSpPr>
        <p:spPr>
          <a:xfrm>
            <a:off x="2558416" y="2259567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E2BB6F92-2E13-D40E-B58B-163177360E63}"/>
              </a:ext>
            </a:extLst>
          </p:cNvPr>
          <p:cNvCxnSpPr>
            <a:cxnSpLocks/>
          </p:cNvCxnSpPr>
          <p:nvPr/>
        </p:nvCxnSpPr>
        <p:spPr>
          <a:xfrm>
            <a:off x="3011900" y="2255853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79EE3BF2-BE7B-DF87-7482-91DE9B59E0D7}"/>
              </a:ext>
            </a:extLst>
          </p:cNvPr>
          <p:cNvCxnSpPr>
            <a:cxnSpLocks/>
          </p:cNvCxnSpPr>
          <p:nvPr/>
        </p:nvCxnSpPr>
        <p:spPr>
          <a:xfrm>
            <a:off x="3502063" y="2254484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A672622D-0BB2-F713-E185-8815FDF0C75C}"/>
              </a:ext>
            </a:extLst>
          </p:cNvPr>
          <p:cNvSpPr txBox="1"/>
          <p:nvPr/>
        </p:nvSpPr>
        <p:spPr>
          <a:xfrm>
            <a:off x="1589881" y="1881013"/>
            <a:ext cx="5453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85F53028-DE45-5A2D-EF03-E3F189133A5A}"/>
              </a:ext>
            </a:extLst>
          </p:cNvPr>
          <p:cNvSpPr txBox="1"/>
          <p:nvPr/>
        </p:nvSpPr>
        <p:spPr>
          <a:xfrm>
            <a:off x="1245251" y="1998061"/>
            <a:ext cx="56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2D7BA55A-77C7-2AB6-651E-2A08373DF493}"/>
              </a:ext>
            </a:extLst>
          </p:cNvPr>
          <p:cNvCxnSpPr>
            <a:cxnSpLocks/>
          </p:cNvCxnSpPr>
          <p:nvPr/>
        </p:nvCxnSpPr>
        <p:spPr>
          <a:xfrm>
            <a:off x="2169057" y="1888028"/>
            <a:ext cx="17267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CDA74F8E-78B0-0165-7AAF-CA0EAAF7AD18}"/>
              </a:ext>
            </a:extLst>
          </p:cNvPr>
          <p:cNvSpPr txBox="1"/>
          <p:nvPr/>
        </p:nvSpPr>
        <p:spPr>
          <a:xfrm>
            <a:off x="2092588" y="2031060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5FAD929-0C1D-C09C-667E-6A0E731BC0FD}"/>
              </a:ext>
            </a:extLst>
          </p:cNvPr>
          <p:cNvSpPr txBox="1"/>
          <p:nvPr/>
        </p:nvSpPr>
        <p:spPr>
          <a:xfrm>
            <a:off x="2513303" y="2029118"/>
            <a:ext cx="76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NK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6833DD1-AB16-F549-5483-35D3640DD30C}"/>
              </a:ext>
            </a:extLst>
          </p:cNvPr>
          <p:cNvSpPr txBox="1"/>
          <p:nvPr/>
        </p:nvSpPr>
        <p:spPr>
          <a:xfrm>
            <a:off x="2876443" y="1998061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3E074EB-D91E-0A27-5A17-2B9136C42485}"/>
              </a:ext>
            </a:extLst>
          </p:cNvPr>
          <p:cNvSpPr txBox="1"/>
          <p:nvPr/>
        </p:nvSpPr>
        <p:spPr>
          <a:xfrm>
            <a:off x="3367603" y="1881013"/>
            <a:ext cx="6595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+pNK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8829435-69D3-037C-6323-EFC0E11311F3}"/>
              </a:ext>
            </a:extLst>
          </p:cNvPr>
          <p:cNvSpPr txBox="1"/>
          <p:nvPr/>
        </p:nvSpPr>
        <p:spPr>
          <a:xfrm>
            <a:off x="2479853" y="1584484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osomes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58F2139B-9569-AF9D-86F8-021A97C2A588}"/>
              </a:ext>
            </a:extLst>
          </p:cNvPr>
          <p:cNvCxnSpPr>
            <a:cxnSpLocks/>
          </p:cNvCxnSpPr>
          <p:nvPr/>
        </p:nvCxnSpPr>
        <p:spPr>
          <a:xfrm flipH="1">
            <a:off x="4328946" y="3032478"/>
            <a:ext cx="406227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645898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>
            <a:extLst>
              <a:ext uri="{FF2B5EF4-FFF2-40B4-BE49-F238E27FC236}">
                <a16:creationId xmlns:a16="http://schemas.microsoft.com/office/drawing/2014/main" id="{72364E60-EF2A-1B45-E3B6-17F488E67254}"/>
              </a:ext>
            </a:extLst>
          </p:cNvPr>
          <p:cNvSpPr txBox="1"/>
          <p:nvPr/>
        </p:nvSpPr>
        <p:spPr>
          <a:xfrm>
            <a:off x="0" y="50808"/>
            <a:ext cx="10663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7/22/22</a:t>
            </a:r>
          </a:p>
          <a:p>
            <a:r>
              <a:rPr lang="en-US" dirty="0"/>
              <a:t>N=3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70AED92-D38F-802E-A71D-2354D2EBF93D}"/>
              </a:ext>
            </a:extLst>
          </p:cNvPr>
          <p:cNvSpPr txBox="1"/>
          <p:nvPr/>
        </p:nvSpPr>
        <p:spPr>
          <a:xfrm>
            <a:off x="2027362" y="650758"/>
            <a:ext cx="1502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5  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88C4E57-D006-4DDA-3644-D2CAB16C01D1}"/>
              </a:ext>
            </a:extLst>
          </p:cNvPr>
          <p:cNvSpPr txBox="1"/>
          <p:nvPr/>
        </p:nvSpPr>
        <p:spPr>
          <a:xfrm>
            <a:off x="2011334" y="1120280"/>
            <a:ext cx="19170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CD63 (50kDa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B161641-9832-1041-027D-8EC47BF505A1}"/>
              </a:ext>
            </a:extLst>
          </p:cNvPr>
          <p:cNvSpPr txBox="1"/>
          <p:nvPr/>
        </p:nvSpPr>
        <p:spPr>
          <a:xfrm>
            <a:off x="7237046" y="3778812"/>
            <a:ext cx="19351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ctin (42 </a:t>
            </a:r>
            <a:r>
              <a:rPr lang="en-US" sz="2000" b="1" dirty="0" err="1"/>
              <a:t>kDa</a:t>
            </a:r>
            <a:r>
              <a:rPr lang="en-US" sz="2000" b="1" dirty="0"/>
              <a:t>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29A2B57-4EB1-9F42-6A31-C56BE48094F6}"/>
              </a:ext>
            </a:extLst>
          </p:cNvPr>
          <p:cNvSpPr txBox="1"/>
          <p:nvPr/>
        </p:nvSpPr>
        <p:spPr>
          <a:xfrm>
            <a:off x="6113343" y="4191244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056AF47-30DD-C852-0D98-2C8C76900A6D}"/>
              </a:ext>
            </a:extLst>
          </p:cNvPr>
          <p:cNvSpPr txBox="1"/>
          <p:nvPr/>
        </p:nvSpPr>
        <p:spPr>
          <a:xfrm>
            <a:off x="6117202" y="4510417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A4B528F-80A8-5590-DA30-E87A2D3EAD1B}"/>
              </a:ext>
            </a:extLst>
          </p:cNvPr>
          <p:cNvSpPr txBox="1"/>
          <p:nvPr/>
        </p:nvSpPr>
        <p:spPr>
          <a:xfrm>
            <a:off x="7634865" y="609046"/>
            <a:ext cx="1502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6 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AC969F8-509D-0FEA-FACD-2DC5118E265C}"/>
              </a:ext>
            </a:extLst>
          </p:cNvPr>
          <p:cNvSpPr txBox="1"/>
          <p:nvPr/>
        </p:nvSpPr>
        <p:spPr>
          <a:xfrm>
            <a:off x="7618837" y="1078568"/>
            <a:ext cx="19170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SG (50kDa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7ECD74-EC92-69BD-62D5-DD90D75BBCFC}"/>
              </a:ext>
            </a:extLst>
          </p:cNvPr>
          <p:cNvSpPr txBox="1"/>
          <p:nvPr/>
        </p:nvSpPr>
        <p:spPr>
          <a:xfrm>
            <a:off x="79830" y="2620615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2573073-63BB-E825-BAEF-5BD39802650F}"/>
              </a:ext>
            </a:extLst>
          </p:cNvPr>
          <p:cNvSpPr txBox="1"/>
          <p:nvPr/>
        </p:nvSpPr>
        <p:spPr>
          <a:xfrm>
            <a:off x="79831" y="2922837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E90A5F5-C401-86C2-8A7B-0200CAF08A8F}"/>
              </a:ext>
            </a:extLst>
          </p:cNvPr>
          <p:cNvSpPr txBox="1"/>
          <p:nvPr/>
        </p:nvSpPr>
        <p:spPr>
          <a:xfrm>
            <a:off x="5981282" y="2566122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1151C18-09C3-CF57-1CCF-A1F4D94AC3CA}"/>
              </a:ext>
            </a:extLst>
          </p:cNvPr>
          <p:cNvSpPr txBox="1"/>
          <p:nvPr/>
        </p:nvSpPr>
        <p:spPr>
          <a:xfrm>
            <a:off x="5981282" y="2839585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3D34DB3-C29D-C5EF-AA02-AD5D124DD3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761065" y="4173641"/>
            <a:ext cx="3743325" cy="619125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A201D739-FCA9-D5EC-9B4E-FBBBC162205D}"/>
              </a:ext>
            </a:extLst>
          </p:cNvPr>
          <p:cNvSpPr txBox="1"/>
          <p:nvPr/>
        </p:nvSpPr>
        <p:spPr>
          <a:xfrm>
            <a:off x="1682713" y="-76180"/>
            <a:ext cx="799720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Adipocytes derived from MSCs-Results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AFD2210-8410-4CB1-994C-7F3200FEE366}"/>
              </a:ext>
            </a:extLst>
          </p:cNvPr>
          <p:cNvCxnSpPr>
            <a:cxnSpLocks/>
          </p:cNvCxnSpPr>
          <p:nvPr/>
        </p:nvCxnSpPr>
        <p:spPr>
          <a:xfrm>
            <a:off x="1372362" y="2046449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45F5DF21-11D9-C451-E987-7C25AE54019E}"/>
              </a:ext>
            </a:extLst>
          </p:cNvPr>
          <p:cNvCxnSpPr>
            <a:cxnSpLocks/>
          </p:cNvCxnSpPr>
          <p:nvPr/>
        </p:nvCxnSpPr>
        <p:spPr>
          <a:xfrm>
            <a:off x="1803542" y="2053886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2D020F74-8A0E-F6BF-F1F6-D97391B876C2}"/>
              </a:ext>
            </a:extLst>
          </p:cNvPr>
          <p:cNvCxnSpPr>
            <a:cxnSpLocks/>
          </p:cNvCxnSpPr>
          <p:nvPr/>
        </p:nvCxnSpPr>
        <p:spPr>
          <a:xfrm>
            <a:off x="2268173" y="2050172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082C8F80-650F-7515-1A8B-2C2827591EC3}"/>
              </a:ext>
            </a:extLst>
          </p:cNvPr>
          <p:cNvCxnSpPr>
            <a:cxnSpLocks/>
          </p:cNvCxnSpPr>
          <p:nvPr/>
        </p:nvCxnSpPr>
        <p:spPr>
          <a:xfrm>
            <a:off x="2688199" y="2057609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2572D6BF-1796-3D62-9BAF-8595E6A1EC56}"/>
              </a:ext>
            </a:extLst>
          </p:cNvPr>
          <p:cNvCxnSpPr>
            <a:cxnSpLocks/>
          </p:cNvCxnSpPr>
          <p:nvPr/>
        </p:nvCxnSpPr>
        <p:spPr>
          <a:xfrm>
            <a:off x="3141683" y="2053895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F91D9465-DE39-9FF3-8988-236473D1A3D8}"/>
              </a:ext>
            </a:extLst>
          </p:cNvPr>
          <p:cNvCxnSpPr>
            <a:cxnSpLocks/>
          </p:cNvCxnSpPr>
          <p:nvPr/>
        </p:nvCxnSpPr>
        <p:spPr>
          <a:xfrm>
            <a:off x="3595689" y="2061121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B1A1B965-2F57-90BB-3BFD-7276F328572C}"/>
              </a:ext>
            </a:extLst>
          </p:cNvPr>
          <p:cNvSpPr txBox="1"/>
          <p:nvPr/>
        </p:nvSpPr>
        <p:spPr>
          <a:xfrm>
            <a:off x="1719664" y="1679055"/>
            <a:ext cx="5453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382F3A3-45C3-8901-B56D-08B980DBF1A4}"/>
              </a:ext>
            </a:extLst>
          </p:cNvPr>
          <p:cNvSpPr txBox="1"/>
          <p:nvPr/>
        </p:nvSpPr>
        <p:spPr>
          <a:xfrm>
            <a:off x="1375034" y="1796103"/>
            <a:ext cx="56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251AA53F-5F7A-0AAB-D605-AE33375DDEA2}"/>
              </a:ext>
            </a:extLst>
          </p:cNvPr>
          <p:cNvCxnSpPr>
            <a:cxnSpLocks/>
          </p:cNvCxnSpPr>
          <p:nvPr/>
        </p:nvCxnSpPr>
        <p:spPr>
          <a:xfrm>
            <a:off x="2298840" y="1686070"/>
            <a:ext cx="17267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68545161-B71E-24B8-5D03-EA383D300EBB}"/>
              </a:ext>
            </a:extLst>
          </p:cNvPr>
          <p:cNvSpPr txBox="1"/>
          <p:nvPr/>
        </p:nvSpPr>
        <p:spPr>
          <a:xfrm>
            <a:off x="2222371" y="1829102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F0025E0-FCA6-34CE-6FC1-D9E41E03D22A}"/>
              </a:ext>
            </a:extLst>
          </p:cNvPr>
          <p:cNvSpPr txBox="1"/>
          <p:nvPr/>
        </p:nvSpPr>
        <p:spPr>
          <a:xfrm>
            <a:off x="2643086" y="1827160"/>
            <a:ext cx="76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NK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488712BD-56E7-D2FC-BB50-93B27C1D0C39}"/>
              </a:ext>
            </a:extLst>
          </p:cNvPr>
          <p:cNvSpPr txBox="1"/>
          <p:nvPr/>
        </p:nvSpPr>
        <p:spPr>
          <a:xfrm>
            <a:off x="3006226" y="1796103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919504C7-0FA2-5E5B-A17A-DCB88D3D9A1B}"/>
              </a:ext>
            </a:extLst>
          </p:cNvPr>
          <p:cNvSpPr txBox="1"/>
          <p:nvPr/>
        </p:nvSpPr>
        <p:spPr>
          <a:xfrm>
            <a:off x="3461229" y="1687650"/>
            <a:ext cx="6595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+pNK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8DF3D38-053D-38AC-39EB-F72255DDDC65}"/>
              </a:ext>
            </a:extLst>
          </p:cNvPr>
          <p:cNvSpPr txBox="1"/>
          <p:nvPr/>
        </p:nvSpPr>
        <p:spPr>
          <a:xfrm>
            <a:off x="2609636" y="1382526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osomes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3FC2D21C-0F37-D400-8CC4-1154ACF9A0F0}"/>
              </a:ext>
            </a:extLst>
          </p:cNvPr>
          <p:cNvCxnSpPr>
            <a:cxnSpLocks/>
          </p:cNvCxnSpPr>
          <p:nvPr/>
        </p:nvCxnSpPr>
        <p:spPr>
          <a:xfrm>
            <a:off x="6998864" y="1994499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AAC5C998-5F39-7E3D-43DF-01FA48DEDA86}"/>
              </a:ext>
            </a:extLst>
          </p:cNvPr>
          <p:cNvCxnSpPr>
            <a:cxnSpLocks/>
          </p:cNvCxnSpPr>
          <p:nvPr/>
        </p:nvCxnSpPr>
        <p:spPr>
          <a:xfrm>
            <a:off x="7430044" y="2001936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3B80D940-8BCD-3970-3724-7D749429C8BE}"/>
              </a:ext>
            </a:extLst>
          </p:cNvPr>
          <p:cNvCxnSpPr>
            <a:cxnSpLocks/>
          </p:cNvCxnSpPr>
          <p:nvPr/>
        </p:nvCxnSpPr>
        <p:spPr>
          <a:xfrm>
            <a:off x="7894675" y="1998222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714E8B2F-206A-AFEB-4C93-2291FC2B957F}"/>
              </a:ext>
            </a:extLst>
          </p:cNvPr>
          <p:cNvCxnSpPr>
            <a:cxnSpLocks/>
          </p:cNvCxnSpPr>
          <p:nvPr/>
        </p:nvCxnSpPr>
        <p:spPr>
          <a:xfrm>
            <a:off x="8314701" y="2005659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B5DA6ABD-827E-4C4D-92E2-86BE4B44433B}"/>
              </a:ext>
            </a:extLst>
          </p:cNvPr>
          <p:cNvCxnSpPr>
            <a:cxnSpLocks/>
          </p:cNvCxnSpPr>
          <p:nvPr/>
        </p:nvCxnSpPr>
        <p:spPr>
          <a:xfrm>
            <a:off x="8768185" y="2001945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3DB6336F-5D9D-F999-5598-D5598733063B}"/>
              </a:ext>
            </a:extLst>
          </p:cNvPr>
          <p:cNvCxnSpPr>
            <a:cxnSpLocks/>
          </p:cNvCxnSpPr>
          <p:nvPr/>
        </p:nvCxnSpPr>
        <p:spPr>
          <a:xfrm>
            <a:off x="9330542" y="2000576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E12F1BA4-60C7-D46D-6285-C453FCEB162F}"/>
              </a:ext>
            </a:extLst>
          </p:cNvPr>
          <p:cNvSpPr txBox="1"/>
          <p:nvPr/>
        </p:nvSpPr>
        <p:spPr>
          <a:xfrm>
            <a:off x="7346166" y="1627105"/>
            <a:ext cx="5453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203F8982-209E-A3B9-5C61-89B3614153DB}"/>
              </a:ext>
            </a:extLst>
          </p:cNvPr>
          <p:cNvSpPr txBox="1"/>
          <p:nvPr/>
        </p:nvSpPr>
        <p:spPr>
          <a:xfrm>
            <a:off x="7001536" y="1744153"/>
            <a:ext cx="56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E3BD540B-72DD-2FEF-3A09-B18F1C75B961}"/>
              </a:ext>
            </a:extLst>
          </p:cNvPr>
          <p:cNvCxnSpPr>
            <a:cxnSpLocks/>
          </p:cNvCxnSpPr>
          <p:nvPr/>
        </p:nvCxnSpPr>
        <p:spPr>
          <a:xfrm>
            <a:off x="7925342" y="1634120"/>
            <a:ext cx="17267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15D5277E-C7B4-16E0-182B-E49592AEC9DF}"/>
              </a:ext>
            </a:extLst>
          </p:cNvPr>
          <p:cNvSpPr txBox="1"/>
          <p:nvPr/>
        </p:nvSpPr>
        <p:spPr>
          <a:xfrm>
            <a:off x="7848873" y="1777152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7B6ABF3B-E66B-8AAA-FE72-D97FA5757C72}"/>
              </a:ext>
            </a:extLst>
          </p:cNvPr>
          <p:cNvSpPr txBox="1"/>
          <p:nvPr/>
        </p:nvSpPr>
        <p:spPr>
          <a:xfrm>
            <a:off x="8269588" y="1775210"/>
            <a:ext cx="76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NK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9FE8D541-13B6-E32E-0954-625D2E400317}"/>
              </a:ext>
            </a:extLst>
          </p:cNvPr>
          <p:cNvSpPr txBox="1"/>
          <p:nvPr/>
        </p:nvSpPr>
        <p:spPr>
          <a:xfrm>
            <a:off x="8632728" y="1744153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F5959D49-ED0A-A116-9776-BD0A582B4CDF}"/>
              </a:ext>
            </a:extLst>
          </p:cNvPr>
          <p:cNvSpPr txBox="1"/>
          <p:nvPr/>
        </p:nvSpPr>
        <p:spPr>
          <a:xfrm>
            <a:off x="9196082" y="1627105"/>
            <a:ext cx="6595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+pNK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1C6723C-BA16-3755-5D83-AB6F2F84721F}"/>
              </a:ext>
            </a:extLst>
          </p:cNvPr>
          <p:cNvSpPr txBox="1"/>
          <p:nvPr/>
        </p:nvSpPr>
        <p:spPr>
          <a:xfrm>
            <a:off x="8236138" y="1330576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osome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1C6473E-0A37-56E0-F0A7-2FE0DC4309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78098" y="2598451"/>
            <a:ext cx="524301" cy="23166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3C04065-77D4-B996-A913-38F8881EB6B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37840" y="2421964"/>
            <a:ext cx="3762375" cy="657225"/>
          </a:xfrm>
          <a:prstGeom prst="rect">
            <a:avLst/>
          </a:prstGeom>
        </p:spPr>
      </p:pic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19B61D8C-A21D-8FF4-EDB6-0135A03DE3B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2558" b="-11032"/>
          <a:stretch/>
        </p:blipFill>
        <p:spPr>
          <a:xfrm>
            <a:off x="748267" y="2110222"/>
            <a:ext cx="3790950" cy="1200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99608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>
            <a:extLst>
              <a:ext uri="{FF2B5EF4-FFF2-40B4-BE49-F238E27FC236}">
                <a16:creationId xmlns:a16="http://schemas.microsoft.com/office/drawing/2014/main" id="{72364E60-EF2A-1B45-E3B6-17F488E67254}"/>
              </a:ext>
            </a:extLst>
          </p:cNvPr>
          <p:cNvSpPr txBox="1"/>
          <p:nvPr/>
        </p:nvSpPr>
        <p:spPr>
          <a:xfrm>
            <a:off x="0" y="50808"/>
            <a:ext cx="10663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7/26/22</a:t>
            </a:r>
          </a:p>
          <a:p>
            <a:r>
              <a:rPr lang="en-US" dirty="0"/>
              <a:t>N=4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70AED92-D38F-802E-A71D-2354D2EBF93D}"/>
              </a:ext>
            </a:extLst>
          </p:cNvPr>
          <p:cNvSpPr txBox="1"/>
          <p:nvPr/>
        </p:nvSpPr>
        <p:spPr>
          <a:xfrm>
            <a:off x="2027362" y="650758"/>
            <a:ext cx="1502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7  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88C4E57-D006-4DDA-3644-D2CAB16C01D1}"/>
              </a:ext>
            </a:extLst>
          </p:cNvPr>
          <p:cNvSpPr txBox="1"/>
          <p:nvPr/>
        </p:nvSpPr>
        <p:spPr>
          <a:xfrm>
            <a:off x="2011334" y="1120280"/>
            <a:ext cx="19170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D63 (50kDa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A4B528F-80A8-5590-DA30-E87A2D3EAD1B}"/>
              </a:ext>
            </a:extLst>
          </p:cNvPr>
          <p:cNvSpPr txBox="1"/>
          <p:nvPr/>
        </p:nvSpPr>
        <p:spPr>
          <a:xfrm>
            <a:off x="7634865" y="609046"/>
            <a:ext cx="1502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mbrane 8 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AC969F8-509D-0FEA-FACD-2DC5118E265C}"/>
              </a:ext>
            </a:extLst>
          </p:cNvPr>
          <p:cNvSpPr txBox="1"/>
          <p:nvPr/>
        </p:nvSpPr>
        <p:spPr>
          <a:xfrm>
            <a:off x="7615112" y="1120280"/>
            <a:ext cx="19170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SG (50kDa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51A0F9D-D1E9-811F-A27C-2D1017111432}"/>
              </a:ext>
            </a:extLst>
          </p:cNvPr>
          <p:cNvSpPr txBox="1"/>
          <p:nvPr/>
        </p:nvSpPr>
        <p:spPr>
          <a:xfrm>
            <a:off x="193869" y="2135167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7ECD74-EC92-69BD-62D5-DD90D75BBCFC}"/>
              </a:ext>
            </a:extLst>
          </p:cNvPr>
          <p:cNvSpPr txBox="1"/>
          <p:nvPr/>
        </p:nvSpPr>
        <p:spPr>
          <a:xfrm>
            <a:off x="193869" y="2339459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2573073-63BB-E825-BAEF-5BD39802650F}"/>
              </a:ext>
            </a:extLst>
          </p:cNvPr>
          <p:cNvSpPr txBox="1"/>
          <p:nvPr/>
        </p:nvSpPr>
        <p:spPr>
          <a:xfrm>
            <a:off x="177751" y="2601070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E90A5F5-C401-86C2-8A7B-0200CAF08A8F}"/>
              </a:ext>
            </a:extLst>
          </p:cNvPr>
          <p:cNvSpPr txBox="1"/>
          <p:nvPr/>
        </p:nvSpPr>
        <p:spPr>
          <a:xfrm>
            <a:off x="6158159" y="2189336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 </a:t>
            </a:r>
            <a:r>
              <a:rPr lang="en-US" sz="1100" dirty="0" err="1"/>
              <a:t>KDa</a:t>
            </a:r>
            <a:endParaRPr lang="en-US" sz="11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1151C18-09C3-CF57-1CCF-A1F4D94AC3CA}"/>
              </a:ext>
            </a:extLst>
          </p:cNvPr>
          <p:cNvSpPr txBox="1"/>
          <p:nvPr/>
        </p:nvSpPr>
        <p:spPr>
          <a:xfrm>
            <a:off x="6158159" y="2462799"/>
            <a:ext cx="5886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 </a:t>
            </a:r>
            <a:r>
              <a:rPr lang="en-US" sz="1100" dirty="0" err="1"/>
              <a:t>KDa</a:t>
            </a:r>
            <a:endParaRPr lang="en-US" sz="11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6F6B7E7-0365-57DB-F0CA-D049CC6CAD7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63000" contrast="2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56706" y="2230304"/>
            <a:ext cx="3724275" cy="666750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31B3436A-923F-9D1F-3886-8800533218D4}"/>
              </a:ext>
            </a:extLst>
          </p:cNvPr>
          <p:cNvSpPr txBox="1"/>
          <p:nvPr/>
        </p:nvSpPr>
        <p:spPr>
          <a:xfrm>
            <a:off x="1682713" y="-76180"/>
            <a:ext cx="799720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Adipocytes derived from MSCs-Results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DA1F6D0-D5FA-F59F-3F89-17B0F4716769}"/>
              </a:ext>
            </a:extLst>
          </p:cNvPr>
          <p:cNvCxnSpPr>
            <a:cxnSpLocks/>
          </p:cNvCxnSpPr>
          <p:nvPr/>
        </p:nvCxnSpPr>
        <p:spPr>
          <a:xfrm>
            <a:off x="1239436" y="2156944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B0341644-9AF6-A0E1-5F0B-B72B01BA3C37}"/>
              </a:ext>
            </a:extLst>
          </p:cNvPr>
          <p:cNvCxnSpPr>
            <a:cxnSpLocks/>
          </p:cNvCxnSpPr>
          <p:nvPr/>
        </p:nvCxnSpPr>
        <p:spPr>
          <a:xfrm>
            <a:off x="1670616" y="2164381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2320CEE-7E0D-5851-AEE1-9F9BB7C6AE6E}"/>
              </a:ext>
            </a:extLst>
          </p:cNvPr>
          <p:cNvCxnSpPr>
            <a:cxnSpLocks/>
          </p:cNvCxnSpPr>
          <p:nvPr/>
        </p:nvCxnSpPr>
        <p:spPr>
          <a:xfrm>
            <a:off x="2135247" y="2160667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60121D6C-8922-7362-2C2A-7C3CD26C772C}"/>
              </a:ext>
            </a:extLst>
          </p:cNvPr>
          <p:cNvCxnSpPr>
            <a:cxnSpLocks/>
          </p:cNvCxnSpPr>
          <p:nvPr/>
        </p:nvCxnSpPr>
        <p:spPr>
          <a:xfrm>
            <a:off x="2555273" y="2168104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A43ECECB-3778-33DF-7EDC-2758FD15C35B}"/>
              </a:ext>
            </a:extLst>
          </p:cNvPr>
          <p:cNvCxnSpPr>
            <a:cxnSpLocks/>
          </p:cNvCxnSpPr>
          <p:nvPr/>
        </p:nvCxnSpPr>
        <p:spPr>
          <a:xfrm>
            <a:off x="3008757" y="2164390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0CA46D55-6B96-8CF1-83A6-F76C62E5B2BB}"/>
              </a:ext>
            </a:extLst>
          </p:cNvPr>
          <p:cNvCxnSpPr>
            <a:cxnSpLocks/>
          </p:cNvCxnSpPr>
          <p:nvPr/>
        </p:nvCxnSpPr>
        <p:spPr>
          <a:xfrm>
            <a:off x="3571114" y="2163021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53DA5B1E-AE5C-E9AA-C264-6613EF91CADB}"/>
              </a:ext>
            </a:extLst>
          </p:cNvPr>
          <p:cNvSpPr txBox="1"/>
          <p:nvPr/>
        </p:nvSpPr>
        <p:spPr>
          <a:xfrm>
            <a:off x="1586738" y="1789550"/>
            <a:ext cx="5453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5FC0FC4-AA03-9E6E-EA62-B60E559E5B44}"/>
              </a:ext>
            </a:extLst>
          </p:cNvPr>
          <p:cNvSpPr txBox="1"/>
          <p:nvPr/>
        </p:nvSpPr>
        <p:spPr>
          <a:xfrm>
            <a:off x="1242108" y="1906598"/>
            <a:ext cx="56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AC8A57A-8E7F-5DFA-3503-50F04BC13014}"/>
              </a:ext>
            </a:extLst>
          </p:cNvPr>
          <p:cNvCxnSpPr>
            <a:cxnSpLocks/>
          </p:cNvCxnSpPr>
          <p:nvPr/>
        </p:nvCxnSpPr>
        <p:spPr>
          <a:xfrm>
            <a:off x="2165914" y="1796565"/>
            <a:ext cx="17267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33AA1A00-DE80-B828-1214-0915AC99247E}"/>
              </a:ext>
            </a:extLst>
          </p:cNvPr>
          <p:cNvSpPr txBox="1"/>
          <p:nvPr/>
        </p:nvSpPr>
        <p:spPr>
          <a:xfrm>
            <a:off x="2089445" y="1939597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C346726-D221-DEE0-40B2-EFBE5D23B9E3}"/>
              </a:ext>
            </a:extLst>
          </p:cNvPr>
          <p:cNvSpPr txBox="1"/>
          <p:nvPr/>
        </p:nvSpPr>
        <p:spPr>
          <a:xfrm>
            <a:off x="2510160" y="1937655"/>
            <a:ext cx="76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NK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BEAC6A0-05D9-266B-9651-884A71904428}"/>
              </a:ext>
            </a:extLst>
          </p:cNvPr>
          <p:cNvSpPr txBox="1"/>
          <p:nvPr/>
        </p:nvSpPr>
        <p:spPr>
          <a:xfrm>
            <a:off x="2873300" y="1906598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4A76C6E-F514-36AE-09C4-633BFC1A2590}"/>
              </a:ext>
            </a:extLst>
          </p:cNvPr>
          <p:cNvSpPr txBox="1"/>
          <p:nvPr/>
        </p:nvSpPr>
        <p:spPr>
          <a:xfrm>
            <a:off x="3436654" y="1789550"/>
            <a:ext cx="6595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+pNK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3D754D1-6F2C-8322-A548-55BD94A5E283}"/>
              </a:ext>
            </a:extLst>
          </p:cNvPr>
          <p:cNvSpPr txBox="1"/>
          <p:nvPr/>
        </p:nvSpPr>
        <p:spPr>
          <a:xfrm>
            <a:off x="2476710" y="1493021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osomes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825CE4C2-A82B-CD38-CE7F-8DF085B98E8C}"/>
              </a:ext>
            </a:extLst>
          </p:cNvPr>
          <p:cNvCxnSpPr>
            <a:cxnSpLocks/>
          </p:cNvCxnSpPr>
          <p:nvPr/>
        </p:nvCxnSpPr>
        <p:spPr>
          <a:xfrm>
            <a:off x="7181180" y="2030285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300FF876-2E39-44CA-6D0D-F80FE9F66264}"/>
              </a:ext>
            </a:extLst>
          </p:cNvPr>
          <p:cNvCxnSpPr>
            <a:cxnSpLocks/>
          </p:cNvCxnSpPr>
          <p:nvPr/>
        </p:nvCxnSpPr>
        <p:spPr>
          <a:xfrm>
            <a:off x="7612360" y="2037722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993F374E-2AEA-6B86-9E2F-140D65186AF7}"/>
              </a:ext>
            </a:extLst>
          </p:cNvPr>
          <p:cNvCxnSpPr>
            <a:cxnSpLocks/>
          </p:cNvCxnSpPr>
          <p:nvPr/>
        </p:nvCxnSpPr>
        <p:spPr>
          <a:xfrm>
            <a:off x="8076991" y="2034008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81A4FEB0-CBE3-525A-9D08-08FCDBE51B70}"/>
              </a:ext>
            </a:extLst>
          </p:cNvPr>
          <p:cNvCxnSpPr>
            <a:cxnSpLocks/>
          </p:cNvCxnSpPr>
          <p:nvPr/>
        </p:nvCxnSpPr>
        <p:spPr>
          <a:xfrm>
            <a:off x="8497017" y="2041445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B9A4F5D9-4DC4-1CD6-963A-5A81E351ACE5}"/>
              </a:ext>
            </a:extLst>
          </p:cNvPr>
          <p:cNvCxnSpPr>
            <a:cxnSpLocks/>
          </p:cNvCxnSpPr>
          <p:nvPr/>
        </p:nvCxnSpPr>
        <p:spPr>
          <a:xfrm>
            <a:off x="8950501" y="2037731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07EF14E0-5D93-286A-21FC-FE08C24A6C1D}"/>
              </a:ext>
            </a:extLst>
          </p:cNvPr>
          <p:cNvCxnSpPr>
            <a:cxnSpLocks/>
          </p:cNvCxnSpPr>
          <p:nvPr/>
        </p:nvCxnSpPr>
        <p:spPr>
          <a:xfrm>
            <a:off x="9512858" y="2036362"/>
            <a:ext cx="3740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0E9FE44E-BA2E-93AD-400E-C43F91822507}"/>
              </a:ext>
            </a:extLst>
          </p:cNvPr>
          <p:cNvSpPr txBox="1"/>
          <p:nvPr/>
        </p:nvSpPr>
        <p:spPr>
          <a:xfrm>
            <a:off x="7528482" y="1662891"/>
            <a:ext cx="5453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D0B8EE8E-3A3C-2B46-78BC-4C3FADEC19CB}"/>
              </a:ext>
            </a:extLst>
          </p:cNvPr>
          <p:cNvSpPr txBox="1"/>
          <p:nvPr/>
        </p:nvSpPr>
        <p:spPr>
          <a:xfrm>
            <a:off x="7183852" y="1779939"/>
            <a:ext cx="560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FB314269-3AEE-6241-59D8-74AD7E15C04E}"/>
              </a:ext>
            </a:extLst>
          </p:cNvPr>
          <p:cNvCxnSpPr>
            <a:cxnSpLocks/>
          </p:cNvCxnSpPr>
          <p:nvPr/>
        </p:nvCxnSpPr>
        <p:spPr>
          <a:xfrm>
            <a:off x="8107658" y="1669906"/>
            <a:ext cx="172677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47D789AE-4EA3-E958-3914-04B4CE1E61F7}"/>
              </a:ext>
            </a:extLst>
          </p:cNvPr>
          <p:cNvSpPr txBox="1"/>
          <p:nvPr/>
        </p:nvSpPr>
        <p:spPr>
          <a:xfrm>
            <a:off x="8031189" y="1812938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8C1C270-9E55-A5F7-CA9F-92888082A43A}"/>
              </a:ext>
            </a:extLst>
          </p:cNvPr>
          <p:cNvSpPr txBox="1"/>
          <p:nvPr/>
        </p:nvSpPr>
        <p:spPr>
          <a:xfrm>
            <a:off x="8451904" y="1810996"/>
            <a:ext cx="76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NK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485BDDDA-2732-E155-8C1C-A088342C4C58}"/>
              </a:ext>
            </a:extLst>
          </p:cNvPr>
          <p:cNvSpPr txBox="1"/>
          <p:nvPr/>
        </p:nvSpPr>
        <p:spPr>
          <a:xfrm>
            <a:off x="8815044" y="1779939"/>
            <a:ext cx="659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F7F16A2F-362D-E148-83ED-E64BB5E146F5}"/>
              </a:ext>
            </a:extLst>
          </p:cNvPr>
          <p:cNvSpPr txBox="1"/>
          <p:nvPr/>
        </p:nvSpPr>
        <p:spPr>
          <a:xfrm>
            <a:off x="9378398" y="1662891"/>
            <a:ext cx="6595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xLDL+pNK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0EE9037-441A-606A-C1B1-C8837D6F4E7E}"/>
              </a:ext>
            </a:extLst>
          </p:cNvPr>
          <p:cNvSpPr txBox="1"/>
          <p:nvPr/>
        </p:nvSpPr>
        <p:spPr>
          <a:xfrm>
            <a:off x="8418454" y="1366362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osome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7D82394-2F03-7379-0910-16D8EF7EEF4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5922" b="39797"/>
          <a:stretch/>
        </p:blipFill>
        <p:spPr>
          <a:xfrm>
            <a:off x="6825484" y="2254667"/>
            <a:ext cx="3619500" cy="8489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3339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14</TotalTime>
  <Words>566</Words>
  <Application>Microsoft Office PowerPoint</Application>
  <PresentationFormat>Widescreen</PresentationFormat>
  <Paragraphs>18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ane Pereira</dc:creator>
  <cp:lastModifiedBy>Sodhi, Komal</cp:lastModifiedBy>
  <cp:revision>109</cp:revision>
  <cp:lastPrinted>2022-07-29T17:46:18Z</cp:lastPrinted>
  <dcterms:created xsi:type="dcterms:W3CDTF">2022-06-03T14:19:44Z</dcterms:created>
  <dcterms:modified xsi:type="dcterms:W3CDTF">2022-08-03T15:28:41Z</dcterms:modified>
</cp:coreProperties>
</file>